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6015AE-88EE-4E49-867B-B00128FD49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85F67-D86C-460B-B3A8-87F27A4D7F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C597A-6397-4DE1-A6E9-501E033B1B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CB5852-2EB4-4206-879B-3A2B643F4A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66142-B744-41BA-A421-9E9A81F025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E8A2F-9D03-4848-A6B6-7122060B15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299F4-106A-486B-9A97-38B8DBF8C8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DB5EB-4563-424F-BF0D-1CD00CC1FD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7546C6-CE38-4815-863D-D410490B89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46BFA-0495-4F4A-BF32-B80CF55A21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55D59F-FF5C-46AF-887C-A584C0C794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0C0A2E-4893-4B1F-9535-60698376F2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9E14244-7B26-40FB-BC8D-BF8EACDD43B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6" descr="profiling4-3groups-mar2015.pdf"/>
          <p:cNvPicPr/>
          <p:nvPr/>
        </p:nvPicPr>
        <p:blipFill>
          <a:blip r:embed="rId1"/>
          <a:stretch/>
        </p:blipFill>
        <p:spPr>
          <a:xfrm>
            <a:off x="687240" y="4624560"/>
            <a:ext cx="5538960" cy="4279680"/>
          </a:xfrm>
          <a:prstGeom prst="rect">
            <a:avLst/>
          </a:prstGeom>
          <a:ln w="0">
            <a:noFill/>
          </a:ln>
        </p:spPr>
      </p:pic>
      <p:sp>
        <p:nvSpPr>
          <p:cNvPr id="42" name="TextBox 1"/>
          <p:cNvSpPr/>
          <p:nvPr/>
        </p:nvSpPr>
        <p:spPr>
          <a:xfrm>
            <a:off x="30240" y="8774280"/>
            <a:ext cx="312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2" descr="Mets-cytokine dec 2014 venkat.pdf"/>
          <p:cNvPicPr/>
          <p:nvPr/>
        </p:nvPicPr>
        <p:blipFill>
          <a:blip r:embed="rId2"/>
          <a:stretch/>
        </p:blipFill>
        <p:spPr>
          <a:xfrm>
            <a:off x="590400" y="17640"/>
            <a:ext cx="5729400" cy="4427280"/>
          </a:xfrm>
          <a:prstGeom prst="rect">
            <a:avLst/>
          </a:prstGeom>
          <a:ln w="0">
            <a:noFill/>
          </a:ln>
        </p:spPr>
      </p:pic>
      <p:sp>
        <p:nvSpPr>
          <p:cNvPr id="44" name="TextBox 4"/>
          <p:cNvSpPr/>
          <p:nvPr/>
        </p:nvSpPr>
        <p:spPr>
          <a:xfrm rot="16200000">
            <a:off x="-241920" y="3132360"/>
            <a:ext cx="15764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P-1 (pg/mL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9"/>
          <p:cNvSpPr/>
          <p:nvPr/>
        </p:nvSpPr>
        <p:spPr>
          <a:xfrm>
            <a:off x="1649520" y="4330800"/>
            <a:ext cx="93168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% Cytotoxic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0"/>
          <p:cNvSpPr/>
          <p:nvPr/>
        </p:nvSpPr>
        <p:spPr>
          <a:xfrm>
            <a:off x="4460760" y="4336920"/>
            <a:ext cx="93024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% Cytotoxic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1"/>
          <p:cNvSpPr/>
          <p:nvPr/>
        </p:nvSpPr>
        <p:spPr>
          <a:xfrm>
            <a:off x="936720" y="44280"/>
            <a:ext cx="24210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pearman correlation = -0.13; p=0.34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2"/>
          <p:cNvSpPr/>
          <p:nvPr/>
        </p:nvSpPr>
        <p:spPr>
          <a:xfrm>
            <a:off x="3814920" y="50760"/>
            <a:ext cx="24192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pearman correlation = -0.04; p=0.7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3"/>
          <p:cNvSpPr/>
          <p:nvPr/>
        </p:nvSpPr>
        <p:spPr>
          <a:xfrm>
            <a:off x="954000" y="2262240"/>
            <a:ext cx="24210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pearman correlation = -0.04; p=0.75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4"/>
          <p:cNvSpPr/>
          <p:nvPr/>
        </p:nvSpPr>
        <p:spPr>
          <a:xfrm>
            <a:off x="3805200" y="2270160"/>
            <a:ext cx="24210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pearman correlation = -0.04; p=0.62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5"/>
          <p:cNvSpPr/>
          <p:nvPr/>
        </p:nvSpPr>
        <p:spPr>
          <a:xfrm rot="16200000">
            <a:off x="6120" y="3171600"/>
            <a:ext cx="155916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200           500      1000    20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6"/>
          <p:cNvSpPr/>
          <p:nvPr/>
        </p:nvSpPr>
        <p:spPr>
          <a:xfrm>
            <a:off x="907920" y="4122720"/>
            <a:ext cx="24498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                  10                20                 30                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7"/>
          <p:cNvSpPr/>
          <p:nvPr/>
        </p:nvSpPr>
        <p:spPr>
          <a:xfrm>
            <a:off x="3776760" y="4148280"/>
            <a:ext cx="244944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                  10                20                 30                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8"/>
          <p:cNvSpPr/>
          <p:nvPr/>
        </p:nvSpPr>
        <p:spPr>
          <a:xfrm rot="16200000">
            <a:off x="2831760" y="3130560"/>
            <a:ext cx="16668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2              5          10         20            5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6"/>
          <p:cNvSpPr/>
          <p:nvPr/>
        </p:nvSpPr>
        <p:spPr>
          <a:xfrm rot="16200000">
            <a:off x="2702880" y="3167280"/>
            <a:ext cx="153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NF (pg/mL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9"/>
          <p:cNvSpPr/>
          <p:nvPr/>
        </p:nvSpPr>
        <p:spPr>
          <a:xfrm>
            <a:off x="954000" y="1935000"/>
            <a:ext cx="244944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                  10                20                 30                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0"/>
          <p:cNvSpPr/>
          <p:nvPr/>
        </p:nvSpPr>
        <p:spPr>
          <a:xfrm>
            <a:off x="3822840" y="1960560"/>
            <a:ext cx="244944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                  10                20                 30                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3"/>
          <p:cNvSpPr/>
          <p:nvPr/>
        </p:nvSpPr>
        <p:spPr>
          <a:xfrm rot="16200000">
            <a:off x="-68760" y="924480"/>
            <a:ext cx="127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L1RA (pg/mL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5"/>
          <p:cNvSpPr/>
          <p:nvPr/>
        </p:nvSpPr>
        <p:spPr>
          <a:xfrm>
            <a:off x="1628640" y="2043000"/>
            <a:ext cx="932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% Cytotoxic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8"/>
          <p:cNvSpPr/>
          <p:nvPr/>
        </p:nvSpPr>
        <p:spPr>
          <a:xfrm>
            <a:off x="4456080" y="2082960"/>
            <a:ext cx="932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% Cytotoxic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1"/>
          <p:cNvSpPr/>
          <p:nvPr/>
        </p:nvSpPr>
        <p:spPr>
          <a:xfrm rot="16200000">
            <a:off x="67680" y="901800"/>
            <a:ext cx="156060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5             20              100            5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2"/>
          <p:cNvSpPr/>
          <p:nvPr/>
        </p:nvSpPr>
        <p:spPr>
          <a:xfrm rot="16200000">
            <a:off x="2808720" y="1042200"/>
            <a:ext cx="166824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1            5                 50               5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7"/>
          <p:cNvSpPr/>
          <p:nvPr/>
        </p:nvSpPr>
        <p:spPr>
          <a:xfrm rot="16200000">
            <a:off x="2784600" y="884160"/>
            <a:ext cx="135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L1A (pg/mL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3"/>
          <p:cNvSpPr/>
          <p:nvPr/>
        </p:nvSpPr>
        <p:spPr>
          <a:xfrm>
            <a:off x="0" y="-11160"/>
            <a:ext cx="68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4"/>
          <p:cNvSpPr/>
          <p:nvPr/>
        </p:nvSpPr>
        <p:spPr>
          <a:xfrm>
            <a:off x="0" y="4432320"/>
            <a:ext cx="68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7"/>
          <p:cNvSpPr/>
          <p:nvPr/>
        </p:nvSpPr>
        <p:spPr>
          <a:xfrm>
            <a:off x="2647800" y="7765920"/>
            <a:ext cx="424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8"/>
          <p:cNvSpPr/>
          <p:nvPr/>
        </p:nvSpPr>
        <p:spPr>
          <a:xfrm>
            <a:off x="4805280" y="7520040"/>
            <a:ext cx="424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29"/>
          <p:cNvSpPr/>
          <p:nvPr/>
        </p:nvSpPr>
        <p:spPr>
          <a:xfrm>
            <a:off x="5497560" y="7015320"/>
            <a:ext cx="42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0"/>
          <p:cNvSpPr/>
          <p:nvPr/>
        </p:nvSpPr>
        <p:spPr>
          <a:xfrm>
            <a:off x="1805040" y="4702320"/>
            <a:ext cx="9223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IL1RA(pg/mL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1"/>
          <p:cNvSpPr/>
          <p:nvPr/>
        </p:nvSpPr>
        <p:spPr>
          <a:xfrm>
            <a:off x="1684440" y="6507000"/>
            <a:ext cx="9302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mar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2"/>
          <p:cNvSpPr/>
          <p:nvPr/>
        </p:nvSpPr>
        <p:spPr>
          <a:xfrm rot="16200000">
            <a:off x="2713680" y="5489640"/>
            <a:ext cx="17780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    100         300          5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3"/>
          <p:cNvSpPr/>
          <p:nvPr/>
        </p:nvSpPr>
        <p:spPr>
          <a:xfrm>
            <a:off x="1066680" y="6491160"/>
            <a:ext cx="7858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4"/>
          <p:cNvSpPr/>
          <p:nvPr/>
        </p:nvSpPr>
        <p:spPr>
          <a:xfrm>
            <a:off x="2631960" y="6502320"/>
            <a:ext cx="4399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e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5"/>
          <p:cNvSpPr/>
          <p:nvPr/>
        </p:nvSpPr>
        <p:spPr>
          <a:xfrm>
            <a:off x="4468680" y="4699080"/>
            <a:ext cx="9223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IL1A (pg/mL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9"/>
          <p:cNvSpPr/>
          <p:nvPr/>
        </p:nvSpPr>
        <p:spPr>
          <a:xfrm>
            <a:off x="1708200" y="6832440"/>
            <a:ext cx="10256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MCP-1 (pg/mL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43"/>
          <p:cNvSpPr/>
          <p:nvPr/>
        </p:nvSpPr>
        <p:spPr>
          <a:xfrm>
            <a:off x="4456080" y="6850080"/>
            <a:ext cx="9223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TNF (pg/mL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47"/>
          <p:cNvSpPr/>
          <p:nvPr/>
        </p:nvSpPr>
        <p:spPr>
          <a:xfrm rot="16200000">
            <a:off x="73800" y="5583960"/>
            <a:ext cx="15242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                 10                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48"/>
          <p:cNvSpPr/>
          <p:nvPr/>
        </p:nvSpPr>
        <p:spPr>
          <a:xfrm rot="16200000">
            <a:off x="66600" y="7634160"/>
            <a:ext cx="169704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          500                    1500    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9"/>
          <p:cNvSpPr/>
          <p:nvPr/>
        </p:nvSpPr>
        <p:spPr>
          <a:xfrm rot="16200000">
            <a:off x="2678040" y="7546320"/>
            <a:ext cx="18651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         10         20          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50"/>
          <p:cNvSpPr/>
          <p:nvPr/>
        </p:nvSpPr>
        <p:spPr>
          <a:xfrm>
            <a:off x="4462560" y="6513480"/>
            <a:ext cx="9302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mar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51"/>
          <p:cNvSpPr/>
          <p:nvPr/>
        </p:nvSpPr>
        <p:spPr>
          <a:xfrm>
            <a:off x="3844800" y="6499080"/>
            <a:ext cx="7844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52"/>
          <p:cNvSpPr/>
          <p:nvPr/>
        </p:nvSpPr>
        <p:spPr>
          <a:xfrm>
            <a:off x="5408640" y="6510240"/>
            <a:ext cx="4413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e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53"/>
          <p:cNvSpPr/>
          <p:nvPr/>
        </p:nvSpPr>
        <p:spPr>
          <a:xfrm>
            <a:off x="1689120" y="8651880"/>
            <a:ext cx="9316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mar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54"/>
          <p:cNvSpPr/>
          <p:nvPr/>
        </p:nvSpPr>
        <p:spPr>
          <a:xfrm>
            <a:off x="1071720" y="8636040"/>
            <a:ext cx="7855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55"/>
          <p:cNvSpPr/>
          <p:nvPr/>
        </p:nvSpPr>
        <p:spPr>
          <a:xfrm>
            <a:off x="2637000" y="8647200"/>
            <a:ext cx="43956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e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56"/>
          <p:cNvSpPr/>
          <p:nvPr/>
        </p:nvSpPr>
        <p:spPr>
          <a:xfrm>
            <a:off x="4473720" y="8647200"/>
            <a:ext cx="9316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mar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57"/>
          <p:cNvSpPr/>
          <p:nvPr/>
        </p:nvSpPr>
        <p:spPr>
          <a:xfrm>
            <a:off x="3855960" y="8632800"/>
            <a:ext cx="7858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58"/>
          <p:cNvSpPr/>
          <p:nvPr/>
        </p:nvSpPr>
        <p:spPr>
          <a:xfrm>
            <a:off x="5421240" y="8643960"/>
            <a:ext cx="4399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e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15T18:32:42Z</dcterms:created>
  <dc:creator>Paulina Wojnarowicz</dc:creator>
  <dc:description/>
  <dc:language>en-US</dc:language>
  <cp:lastModifiedBy>l.latha</cp:lastModifiedBy>
  <dcterms:modified xsi:type="dcterms:W3CDTF">2016-04-13T12:59:05Z</dcterms:modified>
  <cp:revision>6</cp:revision>
  <dc:subject/>
  <dc:title>PowerPoint Presentation</dc:title>
</cp:coreProperties>
</file>